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1" autoAdjust="0"/>
    <p:restoredTop sz="94660"/>
  </p:normalViewPr>
  <p:slideViewPr>
    <p:cSldViewPr snapToGrid="0">
      <p:cViewPr varScale="1">
        <p:scale>
          <a:sx n="51" d="100"/>
          <a:sy n="51" d="100"/>
        </p:scale>
        <p:origin x="2175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96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931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406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265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07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25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370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143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63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66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08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41CCE-7856-4C00-88C3-A7A83D8F5243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36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935DD3-DDC2-1F4D-AF92-802F229C1158}"/>
              </a:ext>
            </a:extLst>
          </p:cNvPr>
          <p:cNvSpPr txBox="1"/>
          <p:nvPr/>
        </p:nvSpPr>
        <p:spPr>
          <a:xfrm>
            <a:off x="2509103" y="86413"/>
            <a:ext cx="428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Table 1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suruda T,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A1FAC03F-029D-2A04-1851-5E4C296619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4986724"/>
              </p:ext>
            </p:extLst>
          </p:nvPr>
        </p:nvGraphicFramePr>
        <p:xfrm>
          <a:off x="508985" y="2243269"/>
          <a:ext cx="5797546" cy="735078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6661">
                  <a:extLst>
                    <a:ext uri="{9D8B030D-6E8A-4147-A177-3AD203B41FA5}">
                      <a16:colId xmlns:a16="http://schemas.microsoft.com/office/drawing/2014/main" val="2333650887"/>
                    </a:ext>
                  </a:extLst>
                </a:gridCol>
                <a:gridCol w="633459">
                  <a:extLst>
                    <a:ext uri="{9D8B030D-6E8A-4147-A177-3AD203B41FA5}">
                      <a16:colId xmlns:a16="http://schemas.microsoft.com/office/drawing/2014/main" val="492542991"/>
                    </a:ext>
                  </a:extLst>
                </a:gridCol>
                <a:gridCol w="1397880">
                  <a:extLst>
                    <a:ext uri="{9D8B030D-6E8A-4147-A177-3AD203B41FA5}">
                      <a16:colId xmlns:a16="http://schemas.microsoft.com/office/drawing/2014/main" val="2426210405"/>
                    </a:ext>
                  </a:extLst>
                </a:gridCol>
                <a:gridCol w="2249546">
                  <a:extLst>
                    <a:ext uri="{9D8B030D-6E8A-4147-A177-3AD203B41FA5}">
                      <a16:colId xmlns:a16="http://schemas.microsoft.com/office/drawing/2014/main" val="14401983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Section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Site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ICC (2, 4)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95% confidence Interval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672045689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GL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6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14-0.98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57786185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Bas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4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87-0.97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94056028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8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766-0.95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684348519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1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35-0.96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14896224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7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40-0.08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29824228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9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799-0.95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310767099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0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799-0.95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99608717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Mid-ventricl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3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69-0.97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89669407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4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94-0.97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79761447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7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737-0.94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380426354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4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81-0.97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383662350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0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08-0.95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14176202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6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21-0.98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363514982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pex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1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32-0.96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07068102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2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57-0.96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233457335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2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30-0.96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413200506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2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48-0.96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6708307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4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84-0.97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389681529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95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0.829-0.94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671363849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5698529-F37A-FDB7-34DE-16BB692DBB63}"/>
              </a:ext>
            </a:extLst>
          </p:cNvPr>
          <p:cNvSpPr txBox="1"/>
          <p:nvPr/>
        </p:nvSpPr>
        <p:spPr>
          <a:xfrm>
            <a:off x="497886" y="9785330"/>
            <a:ext cx="5832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CC, intraclass correlation coefficient; GLS, global longitudinal strain; A, anterior; AS, anteroseptal; IS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roseptal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I, inferior; IL, inferolateral; AL, anterolateral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5247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4</TotalTime>
  <Words>118</Words>
  <Application>Microsoft Office PowerPoint</Application>
  <PresentationFormat>ワイド画面</PresentationFormat>
  <Paragraphs>6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敏博 鶴田</dc:creator>
  <cp:lastModifiedBy>敏博 鶴田</cp:lastModifiedBy>
  <cp:revision>56</cp:revision>
  <dcterms:created xsi:type="dcterms:W3CDTF">2023-11-30T22:48:51Z</dcterms:created>
  <dcterms:modified xsi:type="dcterms:W3CDTF">2024-08-21T01:10:37Z</dcterms:modified>
</cp:coreProperties>
</file>